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47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926C17-BF20-41D7-BD5C-E9AE8CB562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2BF41F8-6F0F-4643-AA9B-E765E9E9CE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5A2BE0E-977F-47DA-8CA7-CA3F06A19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EFC2E17-7BC7-43B2-865E-113750F73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30A28A-7B99-4D47-B126-F72B5CCFC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2366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E22683-D21A-4630-B2EE-FDA0074010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2EFADE4-7656-4068-8F21-6A5FBC88D3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AC6345-3FEA-4C8D-9397-9071F70A4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EEA6D31-C6A0-4E49-ADE4-54E571DB6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61677C3-7C49-446F-ADF6-D8BD2C03B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825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AEFD35F-C2B7-4DEB-B150-A854DE929E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974E016-1DCB-4498-AB89-138684A1D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9601CF7-ED2D-424E-A241-1EC493C2A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C172B61-59C9-4C35-9AE1-8B3003760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E679D7-8E2E-4D03-AB74-D61AE3CB0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88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1B49AD5-6EB4-4E36-A72E-4E0B4B5D4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3E143CA-5985-41DD-B10F-70D52D66D5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F948555-51F2-4F92-B3DC-F10CDC7A1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A78CA67-F5A3-476B-AEA3-35C90875E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D8F1ADB-7DEE-416C-9D89-394842D00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6804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A539E0-0FA3-45A3-9EB2-9A9CCA6F0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5AC9E64-C0CE-40ED-B467-899839881D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D15312D-FC3B-4DDE-A02B-9AA08D4C1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2D23619-9530-4F32-9660-7C06A7ABA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AE82971-94BC-4E1D-B730-A7DE4F1E0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506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946A08-8634-4432-B49B-7BBCDAC36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2153401-B7A1-40AF-93AB-854CD7513A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8F8C882-DF91-45B2-8FC6-00C9EAEDA9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D9098C2-87E3-4DBB-8934-CBD1A0E6B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EAE966C-3FC2-4D85-B181-2F5A2FD58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924C825-D000-46FF-B69B-498D12BAA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9663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54972D-7499-43F8-BDA6-2C6B2403C6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501C7DF-5A23-44AC-A938-EEA06CB491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4EC518A-C255-424E-8310-9AF94895FA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85E0183-08B3-400B-A77D-94ED9323D9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80899B1-868C-43A5-A876-167CF86979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9BD7CBE-F64D-40BB-8088-D935B41D5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F001FF2-6327-4733-9BAC-8BCDA6AD2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EEB9964-E2E2-440D-ACC8-C1D2B9963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0044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C83BF53-7F0C-4EC5-BEC4-4C868BBD2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D5586A0-399A-4305-A5DE-6923D27FD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06B6157-6444-4669-98A7-AD07B2B84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C150898-638F-4EE9-956A-31E2E7A76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5466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D6AF4D1-3AB7-4BE4-BD0A-506CB6BF7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364CA44-C6F6-417C-9B0B-5574EF037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CDF27E0-AB71-4144-A45C-1DD7079A1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354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678392-8625-4B9D-9C51-46E2496C2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14EBA09-4A30-4E66-BFD1-9CD6E44031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A34DDE6-8BEC-4FBB-8922-36B1845898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8BD25D8-4043-4D7E-8ABD-D94693C04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7D34246-D355-4698-B819-6678D9417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A0F8AA2-1DB5-436D-8C91-4819FD886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9468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216467-9998-447B-AF31-BA5B28A9C6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9135813-0169-460F-9829-BD69E49C45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3367F02-8721-4F46-A81E-C3B09AFB3B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0561D4A-0DE7-4D93-B627-E881C7D79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2F3EDB3-0DCE-41B5-B8C9-8A4CB1EDD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F6C23F0-E9FE-44ED-BD26-191826033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2764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BF7CF7A-9E24-44D2-8E7F-AEBC91D9B3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17CFD5C-D429-4712-9AD1-16EACC32C7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D881D61-E038-492C-80BF-BD4369E0B6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0DB7D-9361-4FB6-B6FD-AF212A0A0CCB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029A14-18FE-4C2A-BA1D-385AB360C0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2869AF4-D2B2-4DF8-91E3-E253A29A6C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E1D9E-DB10-4D41-8267-FDF0CBCCFE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17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B8F1AD01-2FE7-4A00-9232-B3DD51E61558}"/>
              </a:ext>
            </a:extLst>
          </p:cNvPr>
          <p:cNvSpPr txBox="1"/>
          <p:nvPr/>
        </p:nvSpPr>
        <p:spPr>
          <a:xfrm>
            <a:off x="5144955" y="650224"/>
            <a:ext cx="338323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The </a:t>
            </a:r>
            <a:r>
              <a:rPr lang="de-DE" dirty="0" err="1"/>
              <a:t>difference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iver</a:t>
            </a:r>
            <a:r>
              <a:rPr lang="de-DE" dirty="0"/>
              <a:t> and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spleen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not </a:t>
            </a:r>
            <a:r>
              <a:rPr lang="de-DE" dirty="0" err="1"/>
              <a:t>associated</a:t>
            </a:r>
            <a:r>
              <a:rPr lang="de-DE" dirty="0"/>
              <a:t> (p&gt;0.200) </a:t>
            </a:r>
            <a:r>
              <a:rPr lang="de-DE" dirty="0" err="1"/>
              <a:t>whil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differenc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iver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correlated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re</a:t>
            </a:r>
            <a:r>
              <a:rPr lang="de-DE" dirty="0"/>
              <a:t> </a:t>
            </a:r>
            <a:r>
              <a:rPr lang="de-DE" dirty="0" err="1"/>
              <a:t>spleen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 (</a:t>
            </a:r>
            <a:r>
              <a:rPr lang="de-DE" dirty="0" err="1"/>
              <a:t>spearman</a:t>
            </a:r>
            <a:r>
              <a:rPr lang="de-DE" dirty="0"/>
              <a:t> </a:t>
            </a:r>
            <a:r>
              <a:rPr lang="de-DE" dirty="0" err="1"/>
              <a:t>correlation</a:t>
            </a:r>
            <a:r>
              <a:rPr lang="de-DE" dirty="0"/>
              <a:t> 0.474, p=0.0299).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A8B0E55A-EC27-4521-8708-7650E865A4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103" y="3105150"/>
            <a:ext cx="4314825" cy="375285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58A42F4A-C536-4ED5-B36C-CF27643981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102" y="-72039"/>
            <a:ext cx="4314825" cy="37528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4DFDEDF-6999-E19A-B791-604305A17107}"/>
              </a:ext>
            </a:extLst>
          </p:cNvPr>
          <p:cNvSpPr txBox="1"/>
          <p:nvPr/>
        </p:nvSpPr>
        <p:spPr>
          <a:xfrm>
            <a:off x="324102" y="23799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  <a:r>
              <a:rPr lang="en-US" altLang="zh-CN" dirty="0"/>
              <a:t>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9191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id="{27A83508-5FE6-4D41-94A9-B397BF2A6F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161" y="0"/>
            <a:ext cx="5955862" cy="6858000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8007C9B3-6A92-4800-9739-BAE8BC310E4E}"/>
              </a:ext>
            </a:extLst>
          </p:cNvPr>
          <p:cNvSpPr txBox="1"/>
          <p:nvPr/>
        </p:nvSpPr>
        <p:spPr>
          <a:xfrm>
            <a:off x="6992983" y="705394"/>
            <a:ext cx="483285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In </a:t>
            </a:r>
            <a:r>
              <a:rPr lang="de-DE" dirty="0" err="1"/>
              <a:t>the</a:t>
            </a:r>
            <a:r>
              <a:rPr lang="de-DE" dirty="0"/>
              <a:t> 21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ligation</a:t>
            </a:r>
            <a:r>
              <a:rPr lang="de-DE" dirty="0"/>
              <a:t>, high Child score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associated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high </a:t>
            </a:r>
            <a:r>
              <a:rPr lang="de-DE" dirty="0" err="1"/>
              <a:t>liver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 </a:t>
            </a:r>
            <a:r>
              <a:rPr lang="de-DE" dirty="0" err="1"/>
              <a:t>before</a:t>
            </a:r>
            <a:r>
              <a:rPr lang="de-DE" dirty="0"/>
              <a:t> and after </a:t>
            </a:r>
            <a:r>
              <a:rPr lang="de-DE" dirty="0" err="1"/>
              <a:t>ligation</a:t>
            </a:r>
            <a:r>
              <a:rPr lang="de-DE" dirty="0"/>
              <a:t> (</a:t>
            </a:r>
            <a:r>
              <a:rPr lang="de-DE" dirty="0" err="1"/>
              <a:t>spearman</a:t>
            </a:r>
            <a:r>
              <a:rPr lang="de-DE" dirty="0"/>
              <a:t> </a:t>
            </a:r>
            <a:r>
              <a:rPr lang="de-DE" dirty="0" err="1"/>
              <a:t>correlation</a:t>
            </a:r>
            <a:r>
              <a:rPr lang="de-DE" dirty="0"/>
              <a:t> 0.3364 </a:t>
            </a:r>
            <a:r>
              <a:rPr lang="de-DE" dirty="0" err="1"/>
              <a:t>with</a:t>
            </a:r>
            <a:r>
              <a:rPr lang="de-DE" dirty="0"/>
              <a:t> p=0.028 and 0.4937 </a:t>
            </a:r>
            <a:r>
              <a:rPr lang="de-DE" dirty="0" err="1"/>
              <a:t>with</a:t>
            </a:r>
            <a:r>
              <a:rPr lang="de-DE" dirty="0"/>
              <a:t> p=0.023, </a:t>
            </a:r>
            <a:r>
              <a:rPr lang="de-DE" dirty="0" err="1"/>
              <a:t>respectively</a:t>
            </a:r>
            <a:r>
              <a:rPr lang="de-DE" dirty="0"/>
              <a:t>) </a:t>
            </a:r>
            <a:r>
              <a:rPr lang="de-DE" dirty="0" err="1"/>
              <a:t>while</a:t>
            </a:r>
            <a:r>
              <a:rPr lang="de-DE" dirty="0"/>
              <a:t> </a:t>
            </a:r>
            <a:r>
              <a:rPr lang="de-DE" dirty="0" err="1"/>
              <a:t>this</a:t>
            </a:r>
            <a:r>
              <a:rPr lang="de-DE" dirty="0"/>
              <a:t> </a:t>
            </a:r>
            <a:r>
              <a:rPr lang="de-DE" dirty="0" err="1"/>
              <a:t>is</a:t>
            </a:r>
            <a:r>
              <a:rPr lang="de-DE" dirty="0"/>
              <a:t> not </a:t>
            </a:r>
            <a:r>
              <a:rPr lang="de-DE" dirty="0" err="1"/>
              <a:t>true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spleen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 (p&gt;0.200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pre</a:t>
            </a:r>
            <a:r>
              <a:rPr lang="de-DE" dirty="0"/>
              <a:t> and </a:t>
            </a:r>
            <a:r>
              <a:rPr lang="de-DE" dirty="0" err="1"/>
              <a:t>post</a:t>
            </a:r>
            <a:r>
              <a:rPr lang="de-DE" dirty="0"/>
              <a:t> </a:t>
            </a:r>
            <a:r>
              <a:rPr lang="de-DE" dirty="0" err="1"/>
              <a:t>assessments</a:t>
            </a:r>
            <a:r>
              <a:rPr lang="de-DE" dirty="0"/>
              <a:t>).</a:t>
            </a:r>
          </a:p>
          <a:p>
            <a:endParaRPr lang="de-DE" dirty="0"/>
          </a:p>
          <a:p>
            <a:r>
              <a:rPr lang="de-DE" dirty="0" err="1"/>
              <a:t>Changes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not </a:t>
            </a:r>
            <a:r>
              <a:rPr lang="de-DE" dirty="0" err="1"/>
              <a:t>significant</a:t>
            </a:r>
            <a:r>
              <a:rPr lang="de-DE" dirty="0"/>
              <a:t> in </a:t>
            </a:r>
            <a:r>
              <a:rPr lang="de-DE" dirty="0" err="1"/>
              <a:t>assessments</a:t>
            </a:r>
            <a:r>
              <a:rPr lang="de-DE" dirty="0"/>
              <a:t> in </a:t>
            </a:r>
            <a:r>
              <a:rPr lang="de-DE" dirty="0" err="1"/>
              <a:t>liver</a:t>
            </a:r>
            <a:r>
              <a:rPr lang="de-DE" dirty="0"/>
              <a:t> and </a:t>
            </a:r>
            <a:r>
              <a:rPr lang="de-DE" dirty="0" err="1"/>
              <a:t>spleen</a:t>
            </a:r>
            <a:r>
              <a:rPr lang="de-DE" dirty="0"/>
              <a:t>, </a:t>
            </a:r>
            <a:r>
              <a:rPr lang="de-DE" dirty="0" err="1"/>
              <a:t>respectively</a:t>
            </a:r>
            <a:r>
              <a:rPr lang="de-DE" dirty="0"/>
              <a:t> (p&gt;0.200)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0F545F3-F419-BB46-BD16-33364CF4B695}"/>
              </a:ext>
            </a:extLst>
          </p:cNvPr>
          <p:cNvSpPr txBox="1"/>
          <p:nvPr/>
        </p:nvSpPr>
        <p:spPr>
          <a:xfrm>
            <a:off x="324102" y="23799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  <a:r>
              <a:rPr lang="en-US" altLang="zh-CN" dirty="0"/>
              <a:t>igur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0682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0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va Herrmann</dc:creator>
  <cp:lastModifiedBy>MDPI</cp:lastModifiedBy>
  <cp:revision>15</cp:revision>
  <dcterms:created xsi:type="dcterms:W3CDTF">2024-12-16T08:34:42Z</dcterms:created>
  <dcterms:modified xsi:type="dcterms:W3CDTF">2026-01-20T01:19:22Z</dcterms:modified>
</cp:coreProperties>
</file>